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94"/>
  </p:normalViewPr>
  <p:slideViewPr>
    <p:cSldViewPr snapToGrid="0">
      <p:cViewPr varScale="1">
        <p:scale>
          <a:sx n="79" d="100"/>
          <a:sy n="79" d="100"/>
        </p:scale>
        <p:origin x="307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13D09D-CBD5-55D2-EF9C-532C15AD59C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1DB7E3C-214D-98C4-2DCB-00EC5D3614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F8A9B9-8948-3772-CCD3-D880875B3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F3F86-3BFE-2D42-A1AF-5D99C5E08AB1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FE5491-21D6-E600-3225-CC1309B126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378257-D2B8-3EC8-3C2D-93FEEB1524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1489A-9BA5-5447-BBF9-CA7FC788CE1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12442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339318-EB8C-D905-E3A6-3DA6127CF5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C94314-C8A5-237D-5E25-CC0A1A2F5D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531C5B-D6DC-A69F-F290-A1B846E65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F3F86-3BFE-2D42-A1AF-5D99C5E08AB1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D77005-8318-3D83-5D7D-46F023B006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FFF395-233A-3B4B-A4C6-A724D3C701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1489A-9BA5-5447-BBF9-CA7FC788CE1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787680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B89D12B-074C-7660-ACB0-7E920664C1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B06622-9D75-0E2D-E8CF-FC0C22066F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8BA411-FCA5-16DA-66F8-52FA28A3A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F3F86-3BFE-2D42-A1AF-5D99C5E08AB1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73160B-4BAE-A1DA-8105-220FD936E1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E1AC3C-EF49-F30C-9036-89DB198FE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1489A-9BA5-5447-BBF9-CA7FC788CE1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462078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4236B5-8E0C-0E0C-535E-9728432FC4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5E79E0-B072-374D-F28D-F9B56F6184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A98CBA-EC94-AE5D-2E41-D5845D9C7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F3F86-3BFE-2D42-A1AF-5D99C5E08AB1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31E33B-E434-7F32-FF1E-8F7ECC904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EF4277-533F-86C3-7EC8-49F53CF57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1489A-9BA5-5447-BBF9-CA7FC788CE1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1764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0197E6-6B9D-D462-2134-E2E3BC276D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98DED2-3125-3C1B-F3F8-C44DA714BC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F53454-8E43-B11B-86AB-5A93FEF0DC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F3F86-3BFE-2D42-A1AF-5D99C5E08AB1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53D0B3-EA18-6124-A91D-AF1EECCBC2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BE765D-9C62-3BE9-7C38-12E1B33B2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1489A-9BA5-5447-BBF9-CA7FC788CE1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90694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2A2A40-E2E3-EB9B-DC0C-A2213C44DE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BB259E-B03C-393B-FF54-B3C0A192715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DA9807-582C-886F-D4BC-3DA218CD49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58A93F-68D6-1EEE-B31C-16C05A55E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F3F86-3BFE-2D42-A1AF-5D99C5E08AB1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82220F-E77D-B415-85FC-425D92FB4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820AD5-F1FF-C5FF-5874-509B37F88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1489A-9BA5-5447-BBF9-CA7FC788CE1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5753698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C61842-F893-8D1E-7B12-81E5569DDE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01A6F7-F48F-3EFE-508D-1580438CA5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37C6F4-8D7A-631A-BFB5-51FE5B9EE8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DA2395B-3B18-CED6-485F-E1D856DE0B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F88114D-B465-CF46-6F11-EC8D7D7998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BFA2D27-10F9-3F13-2240-AD70F1741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F3F86-3BFE-2D42-A1AF-5D99C5E08AB1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91720DF-D3AF-F53E-366E-26F4DBE6B5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4A58848-954D-8DF1-87A7-6D757B5B9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1489A-9BA5-5447-BBF9-CA7FC788CE1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291957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A55504-9A17-6A79-0F7F-068C343337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EC2B26C-59B9-AC2F-87E6-8CC325B26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F3F86-3BFE-2D42-A1AF-5D99C5E08AB1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864AD3-7D39-C67B-75A2-15DD5165A5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4976F6-5B75-8D12-2967-C03C6ADA64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1489A-9BA5-5447-BBF9-CA7FC788CE1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23445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8AA8B6D-E457-68B5-BF89-052212AE49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F3F86-3BFE-2D42-A1AF-5D99C5E08AB1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74F68DB-BAAA-14A0-4F81-2A9CA3DF2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E15A62B-41EA-463A-DD9B-4B0C4BD9FE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1489A-9BA5-5447-BBF9-CA7FC788CE1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293677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27BCAB-F978-0F81-8360-7CF3A315FF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554343-5A74-2516-63C9-90D8B110D7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0E0F02-99A2-F0EC-5499-8324BF3D26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4AE6C7-2F1C-69BF-2D8A-D1FDD840A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F3F86-3BFE-2D42-A1AF-5D99C5E08AB1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D35ABC-3E04-6134-3742-2FA4E2C68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ED6809-1506-27EF-AD61-7E194A162E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1489A-9BA5-5447-BBF9-CA7FC788CE1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93445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F9C0C4-69DC-80CD-01DA-E9AADFCDCF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F7F568-8107-8F26-FE03-A931264B99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7885F74-74C3-A2B5-D9DA-7A33F2E331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301DA9-3508-BB21-212D-A7FF95C90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F3F86-3BFE-2D42-A1AF-5D99C5E08AB1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E35865-6DF4-D2AF-166C-50012DEC9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8418DF-6DD4-2B33-7B78-76ECAE687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1489A-9BA5-5447-BBF9-CA7FC788CE1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888269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E42C60-3E7C-31E5-B5B1-84070EDC36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A2B237-98D3-033B-41A9-EA023E9579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92BBC4-22CF-DE13-B517-F29B57469C2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FCF3F86-3BFE-2D42-A1AF-5D99C5E08AB1}" type="datetimeFigureOut">
              <a:rPr lang="en-DE" smtClean="0"/>
              <a:t>07/16/2025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94E338-ACA8-0A81-F441-84F9320108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EEEB46-B0FD-E666-D904-61B573E73D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01489A-9BA5-5447-BBF9-CA7FC788CE14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732151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B04CA91D-FA01-808C-4A41-54167161D69C}"/>
              </a:ext>
            </a:extLst>
          </p:cNvPr>
          <p:cNvGrpSpPr/>
          <p:nvPr/>
        </p:nvGrpSpPr>
        <p:grpSpPr>
          <a:xfrm>
            <a:off x="3150076" y="1145678"/>
            <a:ext cx="6172200" cy="4739641"/>
            <a:chOff x="0" y="301412"/>
            <a:chExt cx="6172200" cy="4740241"/>
          </a:xfrm>
        </p:grpSpPr>
        <p:sp>
          <p:nvSpPr>
            <p:cNvPr id="6" name="Text Box 2">
              <a:extLst>
                <a:ext uri="{FF2B5EF4-FFF2-40B4-BE49-F238E27FC236}">
                  <a16:creationId xmlns:a16="http://schemas.microsoft.com/office/drawing/2014/main" id="{4E30ED7D-679F-FA1E-A073-9AA3F03E0FFC}"/>
                </a:ext>
              </a:extLst>
            </p:cNvPr>
            <p:cNvSpPr txBox="1"/>
            <p:nvPr/>
          </p:nvSpPr>
          <p:spPr>
            <a:xfrm>
              <a:off x="0" y="2933700"/>
              <a:ext cx="6172200" cy="210795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C572A759-6A51-4108-AA02-DFA0A04FC94B}">
                <ma14:wrappingTextBoxFlag xmlns:lc="http://schemas.openxmlformats.org/drawingml/2006/lockedCanvas" xmlns:oel="http://schemas.microsoft.com/office/2019/extlst" xmlns:w16cex="http://schemas.microsoft.com/office/word/2018/wordml/cex" xmlns:w16="http://schemas.microsoft.com/office/word/2018/wordml" xmlns:w16sdtdh="http://schemas.microsoft.com/office/word/2020/wordml/sdtdatahash" xmlns:arto="http://schemas.microsoft.com/office/word/2006/arto" xmlns:ma14="http://schemas.microsoft.com/office/mac/drawingml/2011/main" xmlns:w="http://schemas.openxmlformats.org/wordprocessingml/2006/main" xmlns:w10="urn:schemas-microsoft-com:office:word" xmlns:v="urn:schemas-microsoft-com:vml" xmlns:o="urn:schemas-microsoft-com:office:office" xmlns:mv="urn:schemas-microsoft-com:mac:vml" xmlns:mo="http://schemas.microsoft.com/office/mac/office/2008/main" xmlns="" xmlns:wps="http://schemas.microsoft.com/office/word/2010/wordprocessingShape" xmlns:wne="http://schemas.microsoft.com/office/word/2006/wordml" xmlns:wpi="http://schemas.microsoft.com/office/word/2010/wordprocessingInk" xmlns:wpg="http://schemas.microsoft.com/office/word/2010/wordprocessingGroup" xmlns:w16se="http://schemas.microsoft.com/office/word/2015/wordml/symex" xmlns:w16cid="http://schemas.microsoft.com/office/word/2016/wordml/cid" xmlns:w15="http://schemas.microsoft.com/office/word/2012/wordml" xmlns:w14="http://schemas.microsoft.com/office/word/2010/wordml" xmlns:wp="http://schemas.openxmlformats.org/drawingml/2006/wordprocessingDrawing" xmlns:wp14="http://schemas.microsoft.com/office/word/2010/wordprocessingDrawing" xmlns:m="http://schemas.openxmlformats.org/officeDocument/2006/math" xmlns:am3d="http://schemas.microsoft.com/office/drawing/2017/model3d" xmlns:aink="http://schemas.microsoft.com/office/drawing/2016/ink" xmlns:mc="http://schemas.openxmlformats.org/markup-compatibility/2006" xmlns:cx8="http://schemas.microsoft.com/office/drawing/2016/5/14/chartex" xmlns:cx7="http://schemas.microsoft.com/office/drawing/2016/5/13/chartex" xmlns:cx6="http://schemas.microsoft.com/office/drawing/2016/5/12/chartex" xmlns:cx5="http://schemas.microsoft.com/office/drawing/2016/5/11/chartex" xmlns:cx4="http://schemas.microsoft.com/office/drawing/2016/5/10/chartex" xmlns:cx3="http://schemas.microsoft.com/office/drawing/2016/5/9/chartex" xmlns:cx2="http://schemas.microsoft.com/office/drawing/2015/10/21/chartex" xmlns:cx1="http://schemas.microsoft.com/office/drawing/2015/9/8/chartex" xmlns:cx="http://schemas.microsoft.com/office/drawing/2014/chartex" xmlns:wpc="http://schemas.microsoft.com/office/word/2010/wordprocessingCanvas"/>
              </a:ext>
            </a:extLst>
          </p:spPr>
          <p:style>
            <a:lnRef idx="0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r>
                <a:rPr lang="en-AU" sz="1000" b="1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Additional File 11: qPCR results from strains expressing collagen III</a:t>
              </a:r>
              <a:br>
                <a:rPr lang="en-AU" sz="1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</a:br>
              <a:r>
                <a:rPr lang="en-AU" sz="1000" b="1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A. Percentage transcript of expression relative to actin of collagen III and </a:t>
              </a:r>
              <a:r>
                <a:rPr lang="en-AU" sz="1000" b="1" dirty="0" err="1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eGFP</a:t>
              </a:r>
              <a:r>
                <a:rPr lang="en-AU" sz="1000" b="1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: </a:t>
              </a:r>
              <a:r>
                <a:rPr lang="en-AU" sz="1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The strain TM18.4 containing the collagen::</a:t>
              </a:r>
              <a:r>
                <a:rPr lang="en-AU" sz="1000" dirty="0" err="1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eGFP</a:t>
              </a:r>
              <a:r>
                <a:rPr lang="en-AU" sz="1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 fusion protein was used in shake flask biomass transfer experiments – 1.0x10</a:t>
              </a:r>
              <a:r>
                <a:rPr lang="en-AU" sz="1000" baseline="30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6</a:t>
              </a:r>
              <a:r>
                <a:rPr lang="en-AU" sz="1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 spores/mL into 25mL CM for outgrowth, biomass washed and transferred to </a:t>
              </a:r>
              <a:r>
                <a:rPr lang="en-AU" sz="1000" dirty="0" err="1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galUA</a:t>
              </a:r>
              <a:r>
                <a:rPr lang="en-AU" sz="1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 medium for 24 h. qPCR was performed as per Materials and Methods. Primers against the collagen III and </a:t>
              </a:r>
              <a:r>
                <a:rPr lang="en-AU" sz="1000" dirty="0" err="1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eGFP</a:t>
              </a:r>
              <a:r>
                <a:rPr lang="en-AU" sz="1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 target the same transcript and a 5-fold increase in expression was observed when the strains were induced with doxycycline (20µg/ml) for the primers targeting </a:t>
              </a:r>
              <a:r>
                <a:rPr lang="en-AU" sz="1000" dirty="0" err="1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eGFP</a:t>
              </a:r>
              <a:r>
                <a:rPr lang="en-AU" sz="1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.</a:t>
              </a:r>
              <a:br>
                <a:rPr lang="en-AU" sz="1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</a:br>
              <a:r>
                <a:rPr lang="en-AU" sz="1000" b="1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B. The effect of DMSO on apparent transcript levels: </a:t>
              </a:r>
              <a:r>
                <a:rPr lang="en-AU" sz="1000" i="1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A. </a:t>
              </a:r>
              <a:r>
                <a:rPr lang="en-AU" sz="1000" i="1" dirty="0" err="1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niger</a:t>
              </a:r>
              <a:r>
                <a:rPr lang="en-AU" sz="1000" i="1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 </a:t>
              </a:r>
              <a:r>
                <a:rPr lang="en-AU" sz="1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collagen expressing strains were used in a biomass transfer experiment (see above) and qPCR performed targeting collagen III. Dox: induced with doxycycline (20µg/mL); U: uninduced. The addition of 5% DMSO to the reaction mixture resulted in a 3 to 5-fold increase in observed transcript levels. </a:t>
              </a:r>
              <a:br>
                <a:rPr lang="en-AU" sz="1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</a:br>
              <a:r>
                <a:rPr lang="en-AU" sz="1000" b="1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C. Transcript levels of the human P4H under a strong, constitutive promoter:  </a:t>
              </a:r>
              <a:r>
                <a:rPr lang="en-AU" sz="1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Total RNA from </a:t>
              </a:r>
              <a:r>
                <a:rPr lang="en-AU" sz="1000" b="1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B. </a:t>
              </a:r>
              <a:r>
                <a:rPr lang="en-AU" sz="1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was used to assess the level of the human P4H relative to actin. The </a:t>
              </a:r>
              <a:r>
                <a:rPr lang="en-AU" sz="1000" i="1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tef1</a:t>
              </a:r>
              <a:r>
                <a:rPr lang="en-AU" sz="1000" dirty="0">
                  <a:effectLst/>
                  <a:latin typeface="Calibri" panose="020F0502020204030204" pitchFamily="34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 promoter shows transcript levels from 100-250% relative to actin. </a:t>
              </a:r>
              <a:endParaRPr lang="en-DE" sz="1000" dirty="0">
                <a:effectLst/>
                <a:latin typeface="Helvetica" pitchFamily="2" charset="0"/>
                <a:ea typeface="MS Mincho" panose="02020609040205080304" pitchFamily="49" charset="-128"/>
                <a:cs typeface="Times New Roman" panose="02020603050405020304" pitchFamily="18" charset="0"/>
              </a:endParaRP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947038E-584A-2DE7-ED0A-A3B83C5BEEF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01040" y="301412"/>
              <a:ext cx="4774565" cy="266000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985399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MS Mincho</vt:lpstr>
      <vt:lpstr>Aptos</vt:lpstr>
      <vt:lpstr>Aptos Display</vt:lpstr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U-Pseudonym 1517372033116741</dc:creator>
  <cp:lastModifiedBy>tom.morris</cp:lastModifiedBy>
  <cp:revision>2</cp:revision>
  <dcterms:created xsi:type="dcterms:W3CDTF">2024-11-19T17:25:40Z</dcterms:created>
  <dcterms:modified xsi:type="dcterms:W3CDTF">2025-07-16T07:48:09Z</dcterms:modified>
</cp:coreProperties>
</file>